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5" autoAdjust="0"/>
    <p:restoredTop sz="94660"/>
  </p:normalViewPr>
  <p:slideViewPr>
    <p:cSldViewPr snapToGrid="0">
      <p:cViewPr>
        <p:scale>
          <a:sx n="84" d="100"/>
          <a:sy n="84" d="100"/>
        </p:scale>
        <p:origin x="1380" y="-2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822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679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342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7600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907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589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11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031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889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2256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484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87B2CC-82C8-4342-AD52-01C13F6AF45F}" type="datetimeFigureOut">
              <a:rPr lang="en-US" smtClean="0"/>
              <a:t>9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1E10D-BC14-481E-A0EB-C7A13DB7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0058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406D3F0-C655-0EF8-C54E-36E5A37CBECA}"/>
              </a:ext>
            </a:extLst>
          </p:cNvPr>
          <p:cNvSpPr txBox="1"/>
          <p:nvPr/>
        </p:nvSpPr>
        <p:spPr>
          <a:xfrm>
            <a:off x="150707" y="6594138"/>
            <a:ext cx="7225453" cy="32966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3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ption of Supplemental Figure 1</a:t>
            </a:r>
          </a:p>
          <a:p>
            <a:pPr marL="0" marR="0" algn="just">
              <a:lnSpc>
                <a:spcPct val="13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272525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Down-regulation of CD44v6 impairs sustained β-catenin activation and inhibits the G1–S transition. 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-B),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lidations of CD44v6 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RNAs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v6 sh1 and v6 sh2) and WNT3A </a:t>
            </a:r>
            <a:r>
              <a:rPr lang="en-US" sz="105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hRNAs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WNT3A sh1 and WNT3A sh2) used in panels 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-G)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ere done by the indicated shRNA mediated knockdown and the corresponding knock-in (KI) gene transfections in SW480-FR cells as described in Methods.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rget proteins were analyzed by WB analysis (β-tubulin, internal control).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C),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effect of shRNA-mediated knockdown of CD44v6 in SW480-FR cells on the expression of CD44v6 mRNA was determined by real-time PCR (at 24 h; RQ, relative quantification). Validation of expression vector CD44v6 cDNA (v6 cDNA) was done by WB analysis (β-tubulin, internal control) </a:t>
            </a:r>
            <a:r>
              <a:rPr lang="en-US" sz="105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D),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ar graph summarizing the flow cytometry cell cycle profile analysis after WNT3A stimulation in G2.M-arrested-SW480-cells which were previously transfected with NT shRNA or v6 shRNA for 24 hours. These cells were collected at indicated times after WNT3A -stimulation and cell cycle were analyzed (details in Method section).</a:t>
            </a:r>
          </a:p>
          <a:p>
            <a:pPr marL="0" marR="0" algn="just">
              <a:lnSpc>
                <a:spcPct val="12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are presented as Mean ± SD from n</a:t>
            </a:r>
            <a:r>
              <a:rPr lang="en-US" sz="105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3 </a:t>
            </a:r>
            <a:r>
              <a:rPr lang="en-US" sz="1050" dirty="0">
                <a:effectLst/>
                <a:latin typeface="Arial" panose="020B0604020202020204" pitchFamily="34" charset="0"/>
                <a:ea typeface="Microsoft JhengHei UI Light" panose="020B0304030504040204" pitchFamily="34" charset="-120"/>
                <a:cs typeface="Arial" panose="020B0604020202020204" pitchFamily="34" charset="0"/>
              </a:rPr>
              <a:t>replicates in three independent experiments</a:t>
            </a:r>
            <a:r>
              <a:rPr lang="en-US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FACs data are representative of three experiments *, P &lt; 0.05, **, P &lt; 0.01 were considered significant, percent cells in S phase in CD44v6 shRNA transfected cells compared with NT shRNA transfected cell</a:t>
            </a:r>
          </a:p>
        </p:txBody>
      </p:sp>
      <p:pic>
        <p:nvPicPr>
          <p:cNvPr id="6" name="Picture 5" descr="Diagram, schematic&#10;&#10;Description automatically generated">
            <a:extLst>
              <a:ext uri="{FF2B5EF4-FFF2-40B4-BE49-F238E27FC236}">
                <a16:creationId xmlns:a16="http://schemas.microsoft.com/office/drawing/2014/main" id="{8E07888D-E4B2-A64D-C800-0E7C6DF5BF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737" y="167590"/>
            <a:ext cx="5941423" cy="6379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3225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2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iti Misra</dc:creator>
  <cp:lastModifiedBy>Suniti Misra</cp:lastModifiedBy>
  <cp:revision>3</cp:revision>
  <dcterms:created xsi:type="dcterms:W3CDTF">2022-07-06T23:07:06Z</dcterms:created>
  <dcterms:modified xsi:type="dcterms:W3CDTF">2022-09-10T18:35:51Z</dcterms:modified>
</cp:coreProperties>
</file>